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1374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E15F69-B1D4-4674-8C50-7ACF7A2E90FA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B8AC788-8E20-4E23-B677-CE65EE20708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0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7411" name="Notes Placeholder 2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smtClean="0"/>
          </a:p>
        </p:txBody>
      </p:sp>
      <p:sp>
        <p:nvSpPr>
          <p:cNvPr id="17412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/>
          <a:lstStyle/>
          <a:p>
            <a:fld id="{E704DB82-D581-449A-B228-8A482332AC24}" type="slidenum">
              <a:rPr lang="en-US" smtClean="0"/>
              <a:pPr/>
              <a:t>1</a:t>
            </a:fld>
            <a:endParaRPr 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2ED8C-FEC7-4D05-B9F5-CED022F6D7FF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24CF-BC4C-4F6B-AB58-462CC36543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2ED8C-FEC7-4D05-B9F5-CED022F6D7FF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24CF-BC4C-4F6B-AB58-462CC36543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2ED8C-FEC7-4D05-B9F5-CED022F6D7FF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24CF-BC4C-4F6B-AB58-462CC36543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2ED8C-FEC7-4D05-B9F5-CED022F6D7FF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24CF-BC4C-4F6B-AB58-462CC36543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2ED8C-FEC7-4D05-B9F5-CED022F6D7FF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24CF-BC4C-4F6B-AB58-462CC36543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2ED8C-FEC7-4D05-B9F5-CED022F6D7FF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24CF-BC4C-4F6B-AB58-462CC36543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2ED8C-FEC7-4D05-B9F5-CED022F6D7FF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24CF-BC4C-4F6B-AB58-462CC36543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2ED8C-FEC7-4D05-B9F5-CED022F6D7FF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24CF-BC4C-4F6B-AB58-462CC36543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2ED8C-FEC7-4D05-B9F5-CED022F6D7FF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24CF-BC4C-4F6B-AB58-462CC36543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2ED8C-FEC7-4D05-B9F5-CED022F6D7FF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24CF-BC4C-4F6B-AB58-462CC36543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62ED8C-FEC7-4D05-B9F5-CED022F6D7FF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024CF-BC4C-4F6B-AB58-462CC365430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62ED8C-FEC7-4D05-B9F5-CED022F6D7FF}" type="datetimeFigureOut">
              <a:rPr lang="en-US" smtClean="0"/>
              <a:pPr/>
              <a:t>4/3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2024CF-BC4C-4F6B-AB58-462CC365430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54" name="TextBox 9"/>
          <p:cNvSpPr txBox="1">
            <a:spLocks noChangeArrowheads="1"/>
          </p:cNvSpPr>
          <p:nvPr/>
        </p:nvSpPr>
        <p:spPr bwMode="auto">
          <a:xfrm>
            <a:off x="0" y="0"/>
            <a:ext cx="506724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0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9"/>
          <p:cNvSpPr txBox="1">
            <a:spLocks noChangeArrowheads="1"/>
          </p:cNvSpPr>
          <p:nvPr/>
        </p:nvSpPr>
        <p:spPr bwMode="auto">
          <a:xfrm>
            <a:off x="4427984" y="0"/>
            <a:ext cx="506724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0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0" y="764704"/>
            <a:ext cx="4572000" cy="18482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5" name="TextBox 9"/>
          <p:cNvSpPr txBox="1">
            <a:spLocks noChangeArrowheads="1"/>
          </p:cNvSpPr>
          <p:nvPr/>
        </p:nvSpPr>
        <p:spPr bwMode="auto">
          <a:xfrm>
            <a:off x="971600" y="548680"/>
            <a:ext cx="288032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0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9"/>
          <p:cNvSpPr txBox="1">
            <a:spLocks noChangeArrowheads="1"/>
          </p:cNvSpPr>
          <p:nvPr/>
        </p:nvSpPr>
        <p:spPr bwMode="auto">
          <a:xfrm>
            <a:off x="3131840" y="620688"/>
            <a:ext cx="36004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0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499992" y="764704"/>
            <a:ext cx="4644008" cy="18439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8" name="TextBox 9"/>
          <p:cNvSpPr txBox="1">
            <a:spLocks noChangeArrowheads="1"/>
          </p:cNvSpPr>
          <p:nvPr/>
        </p:nvSpPr>
        <p:spPr bwMode="auto">
          <a:xfrm>
            <a:off x="5508104" y="548680"/>
            <a:ext cx="288032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0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9"/>
          <p:cNvSpPr txBox="1">
            <a:spLocks noChangeArrowheads="1"/>
          </p:cNvSpPr>
          <p:nvPr/>
        </p:nvSpPr>
        <p:spPr bwMode="auto">
          <a:xfrm>
            <a:off x="7740352" y="548680"/>
            <a:ext cx="36004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0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" name="Picture 6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499992" y="3068960"/>
            <a:ext cx="4419349" cy="17713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" name="Picture 7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0" y="2780928"/>
            <a:ext cx="4527583" cy="20882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7" name="TextBox 9"/>
          <p:cNvSpPr txBox="1">
            <a:spLocks noChangeArrowheads="1"/>
          </p:cNvSpPr>
          <p:nvPr/>
        </p:nvSpPr>
        <p:spPr bwMode="auto">
          <a:xfrm>
            <a:off x="3203848" y="2852936"/>
            <a:ext cx="288032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0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9"/>
          <p:cNvSpPr txBox="1">
            <a:spLocks noChangeArrowheads="1"/>
          </p:cNvSpPr>
          <p:nvPr/>
        </p:nvSpPr>
        <p:spPr bwMode="auto">
          <a:xfrm>
            <a:off x="1043608" y="2780928"/>
            <a:ext cx="288032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0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9"/>
          <p:cNvSpPr txBox="1">
            <a:spLocks noChangeArrowheads="1"/>
          </p:cNvSpPr>
          <p:nvPr/>
        </p:nvSpPr>
        <p:spPr bwMode="auto">
          <a:xfrm>
            <a:off x="4499992" y="2636912"/>
            <a:ext cx="506724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000" b="1" dirty="0" smtClean="0">
                <a:latin typeface="Times New Roman" pitchFamily="18" charset="0"/>
                <a:cs typeface="Times New Roman" pitchFamily="18" charset="0"/>
              </a:rPr>
              <a:t>D</a:t>
            </a:r>
            <a:endParaRPr 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9"/>
          <p:cNvSpPr txBox="1">
            <a:spLocks noChangeArrowheads="1"/>
          </p:cNvSpPr>
          <p:nvPr/>
        </p:nvSpPr>
        <p:spPr bwMode="auto">
          <a:xfrm>
            <a:off x="0" y="2564904"/>
            <a:ext cx="506724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0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TextBox 9"/>
          <p:cNvSpPr txBox="1">
            <a:spLocks noChangeArrowheads="1"/>
          </p:cNvSpPr>
          <p:nvPr/>
        </p:nvSpPr>
        <p:spPr bwMode="auto">
          <a:xfrm>
            <a:off x="5436096" y="2780928"/>
            <a:ext cx="288032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0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TextBox 9"/>
          <p:cNvSpPr txBox="1">
            <a:spLocks noChangeArrowheads="1"/>
          </p:cNvSpPr>
          <p:nvPr/>
        </p:nvSpPr>
        <p:spPr bwMode="auto">
          <a:xfrm>
            <a:off x="7452320" y="2780928"/>
            <a:ext cx="288032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20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179512" y="5013176"/>
            <a:ext cx="8640960" cy="17064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400" b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sz="1400" b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S2. </a:t>
            </a:r>
            <a:r>
              <a:rPr lang="en-US" sz="14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Resource mobilization genes are up-regulated rapidly in infested resistant plants.  </a:t>
            </a:r>
            <a:r>
              <a:rPr lang="en-US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sz="14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) Genes involved in lipid catabolism (Table S3). (</a:t>
            </a:r>
            <a:r>
              <a:rPr lang="en-US" sz="14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) Percentages of lipid-related genes that were up- (darker bar) or down-regulated (lighter bar) in plants during incompatible (I) and compatible (C) interactions. (</a:t>
            </a:r>
            <a:r>
              <a:rPr lang="en-US" sz="14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) Average fold changes of lipid-related genes at different time points after Hessian fly infestation. IU, ID, CU, and CD represent fold changes of up-regulated transcripts during incompatible interaction, of down-regulated transcripts during incompatible interactions, of up-regulated transcripts during compatible interactions, and of down-regulated transcripts during compatible interactions. (</a:t>
            </a:r>
            <a:r>
              <a:rPr lang="en-US" sz="14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) Genes encoding other types of transporters. (</a:t>
            </a:r>
            <a:r>
              <a:rPr lang="en-US" sz="14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</a:t>
            </a:r>
            <a:r>
              <a:rPr lang="en-US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) Genes encoding carbohydrate and protein/amino acid catabolic enzymes. (</a:t>
            </a:r>
            <a:r>
              <a:rPr lang="en-US" sz="14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D</a:t>
            </a:r>
            <a:r>
              <a:rPr lang="en-US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) Genes encoding various anabolic enzymes. </a:t>
            </a:r>
            <a:endParaRPr lang="en-US" sz="1400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899592" y="404664"/>
            <a:ext cx="6991350" cy="228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1</TotalTime>
  <Words>162</Words>
  <Application>Microsoft Office PowerPoint</Application>
  <PresentationFormat>On-screen Show (4:3)</PresentationFormat>
  <Paragraphs>1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ng</dc:creator>
  <cp:lastModifiedBy>M CHEN</cp:lastModifiedBy>
  <cp:revision>175</cp:revision>
  <dcterms:created xsi:type="dcterms:W3CDTF">2012-06-02T17:01:32Z</dcterms:created>
  <dcterms:modified xsi:type="dcterms:W3CDTF">2013-04-30T19:08:35Z</dcterms:modified>
</cp:coreProperties>
</file>